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65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91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64"/>
    <p:restoredTop sz="94643"/>
  </p:normalViewPr>
  <p:slideViewPr>
    <p:cSldViewPr snapToGrid="0" snapToObjects="1" showGuides="1">
      <p:cViewPr>
        <p:scale>
          <a:sx n="116" d="100"/>
          <a:sy n="116" d="100"/>
        </p:scale>
        <p:origin x="392" y="168"/>
      </p:cViewPr>
      <p:guideLst>
        <p:guide orient="horz" pos="2591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localhost/Users/wickyc/Documents/Results/Peter/Sup%20paper/Submission%20G3/Revised/Accepted/sumCW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localhost/Users/wickyc/Documents/Results/Peter/Sup%20paper/Submission%20G3/Revised/Accepted/sumCW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localhost/Users/wickyc/Documents/Results/Peter/Sup%20paper/Submission%20G3/Revised/Accepted/sumCW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i="1"/>
              <a:t>dct-3 </a:t>
            </a:r>
            <a:r>
              <a:rPr lang="en-US"/>
              <a:t>mRNA level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22793963254593"/>
          <c:y val="0.186847997261212"/>
          <c:w val="0.81053937007874"/>
          <c:h val="0.74358678534748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F$7:$F$10</c:f>
                <c:numCache>
                  <c:formatCode>General</c:formatCode>
                  <c:ptCount val="4"/>
                  <c:pt idx="1">
                    <c:v>0.0211743233664872</c:v>
                  </c:pt>
                  <c:pt idx="2">
                    <c:v>0.0232036203125887</c:v>
                  </c:pt>
                  <c:pt idx="3">
                    <c:v>0.0450354973744109</c:v>
                  </c:pt>
                </c:numCache>
              </c:numRef>
            </c:plus>
            <c:minus>
              <c:numRef>
                <c:f>Sheet3!$F$7:$F$10</c:f>
                <c:numCache>
                  <c:formatCode>General</c:formatCode>
                  <c:ptCount val="4"/>
                  <c:pt idx="1">
                    <c:v>0.0211743233664872</c:v>
                  </c:pt>
                  <c:pt idx="2">
                    <c:v>0.0232036203125887</c:v>
                  </c:pt>
                  <c:pt idx="3">
                    <c:v>0.0450354973744109</c:v>
                  </c:pt>
                </c:numCache>
              </c:numRef>
            </c:minus>
          </c:errBars>
          <c:cat>
            <c:strRef>
              <c:f>Sheet3!$D$7:$D$10</c:f>
              <c:strCache>
                <c:ptCount val="4"/>
                <c:pt idx="0">
                  <c:v>wt</c:v>
                </c:pt>
                <c:pt idx="1">
                  <c:v>let-418</c:v>
                </c:pt>
                <c:pt idx="2">
                  <c:v>daf-16</c:v>
                </c:pt>
                <c:pt idx="3">
                  <c:v>daf-16;let-418</c:v>
                </c:pt>
              </c:strCache>
            </c:strRef>
          </c:cat>
          <c:val>
            <c:numRef>
              <c:f>Sheet3!$E$7:$E$10</c:f>
              <c:numCache>
                <c:formatCode>General</c:formatCode>
                <c:ptCount val="4"/>
                <c:pt idx="0">
                  <c:v>0.0</c:v>
                </c:pt>
                <c:pt idx="1">
                  <c:v>1.450249108319361</c:v>
                </c:pt>
                <c:pt idx="2">
                  <c:v>-1.467594290404534</c:v>
                </c:pt>
                <c:pt idx="3">
                  <c:v>1.25285303097989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65309088"/>
        <c:axId val="-2064760256"/>
      </c:barChart>
      <c:catAx>
        <c:axId val="-20653090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-2064760256"/>
        <c:crosses val="autoZero"/>
        <c:auto val="1"/>
        <c:lblAlgn val="ctr"/>
        <c:lblOffset val="100"/>
        <c:noMultiLvlLbl val="0"/>
      </c:catAx>
      <c:valAx>
        <c:axId val="-2064760256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Log</a:t>
                </a:r>
                <a:r>
                  <a:rPr lang="en-US" baseline="0"/>
                  <a:t> relative expression</a:t>
                </a:r>
                <a:endParaRPr 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6530908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800" b="1" i="1" baseline="0">
                <a:effectLst/>
              </a:rPr>
              <a:t>W08A12.4 </a:t>
            </a:r>
            <a:r>
              <a:rPr lang="en-US" sz="1800" b="1" i="0" baseline="0">
                <a:effectLst/>
              </a:rPr>
              <a:t>mRNA level</a:t>
            </a:r>
            <a:endParaRPr lang="en-US">
              <a:effectLst/>
            </a:endParaRP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53349518810149"/>
          <c:y val="0.186847997261212"/>
          <c:w val="0.81053937007874"/>
          <c:h val="0.74358678534748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M$7:$M$10</c:f>
                <c:numCache>
                  <c:formatCode>General</c:formatCode>
                  <c:ptCount val="4"/>
                  <c:pt idx="1">
                    <c:v>0.021174323</c:v>
                  </c:pt>
                  <c:pt idx="2">
                    <c:v>0.02320362</c:v>
                  </c:pt>
                  <c:pt idx="3">
                    <c:v>0.045035497</c:v>
                  </c:pt>
                </c:numCache>
              </c:numRef>
            </c:plus>
            <c:minus>
              <c:numRef>
                <c:f>Sheet3!$M$7:$M$10</c:f>
                <c:numCache>
                  <c:formatCode>General</c:formatCode>
                  <c:ptCount val="4"/>
                  <c:pt idx="1">
                    <c:v>0.021174323</c:v>
                  </c:pt>
                  <c:pt idx="2">
                    <c:v>0.02320362</c:v>
                  </c:pt>
                  <c:pt idx="3">
                    <c:v>0.045035497</c:v>
                  </c:pt>
                </c:numCache>
              </c:numRef>
            </c:minus>
          </c:errBars>
          <c:cat>
            <c:strRef>
              <c:f>Sheet3!$K$7:$K$10</c:f>
              <c:strCache>
                <c:ptCount val="4"/>
                <c:pt idx="0">
                  <c:v>wt</c:v>
                </c:pt>
                <c:pt idx="1">
                  <c:v>let-418</c:v>
                </c:pt>
                <c:pt idx="2">
                  <c:v>daf-16</c:v>
                </c:pt>
                <c:pt idx="3">
                  <c:v>daf-16;let-418</c:v>
                </c:pt>
              </c:strCache>
            </c:strRef>
          </c:cat>
          <c:val>
            <c:numRef>
              <c:f>Sheet3!$L$7:$L$10</c:f>
              <c:numCache>
                <c:formatCode>General</c:formatCode>
                <c:ptCount val="4"/>
                <c:pt idx="0">
                  <c:v>0.0</c:v>
                </c:pt>
                <c:pt idx="1">
                  <c:v>1.584331224367531</c:v>
                </c:pt>
                <c:pt idx="2">
                  <c:v>-1.375541722295432</c:v>
                </c:pt>
                <c:pt idx="3">
                  <c:v>1.13987908640123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35923360"/>
        <c:axId val="-2119019376"/>
      </c:barChart>
      <c:catAx>
        <c:axId val="-20359233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-2119019376"/>
        <c:crosses val="autoZero"/>
        <c:auto val="1"/>
        <c:lblAlgn val="ctr"/>
        <c:lblOffset val="100"/>
        <c:noMultiLvlLbl val="0"/>
      </c:catAx>
      <c:valAx>
        <c:axId val="-2119019376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Log relative express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3592336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800" b="1" i="1" baseline="0">
                <a:effectLst/>
              </a:rPr>
              <a:t>fbxa-165 </a:t>
            </a:r>
            <a:r>
              <a:rPr lang="en-US" sz="1800" b="1" i="0" baseline="0">
                <a:effectLst/>
              </a:rPr>
              <a:t>mRNA level</a:t>
            </a:r>
            <a:endParaRPr lang="en-US">
              <a:effectLst/>
            </a:endParaRP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U$7:$U$10</c:f>
                <c:numCache>
                  <c:formatCode>General</c:formatCode>
                  <c:ptCount val="4"/>
                  <c:pt idx="1">
                    <c:v>0.021174323</c:v>
                  </c:pt>
                  <c:pt idx="2">
                    <c:v>0.02320362</c:v>
                  </c:pt>
                  <c:pt idx="3">
                    <c:v>0.045035497</c:v>
                  </c:pt>
                </c:numCache>
              </c:numRef>
            </c:plus>
            <c:minus>
              <c:numRef>
                <c:f>Sheet3!$U$7:$U$10</c:f>
                <c:numCache>
                  <c:formatCode>General</c:formatCode>
                  <c:ptCount val="4"/>
                  <c:pt idx="1">
                    <c:v>0.021174323</c:v>
                  </c:pt>
                  <c:pt idx="2">
                    <c:v>0.02320362</c:v>
                  </c:pt>
                  <c:pt idx="3">
                    <c:v>0.045035497</c:v>
                  </c:pt>
                </c:numCache>
              </c:numRef>
            </c:minus>
          </c:errBars>
          <c:cat>
            <c:strRef>
              <c:f>Sheet3!$S$7:$S$10</c:f>
              <c:strCache>
                <c:ptCount val="4"/>
                <c:pt idx="0">
                  <c:v>wt</c:v>
                </c:pt>
                <c:pt idx="1">
                  <c:v>let-418</c:v>
                </c:pt>
                <c:pt idx="2">
                  <c:v>daf-16</c:v>
                </c:pt>
                <c:pt idx="3">
                  <c:v>daf-16;let-418</c:v>
                </c:pt>
              </c:strCache>
            </c:strRef>
          </c:cat>
          <c:val>
            <c:numRef>
              <c:f>Sheet3!$T$7:$T$10</c:f>
              <c:numCache>
                <c:formatCode>General</c:formatCode>
                <c:ptCount val="4"/>
                <c:pt idx="0">
                  <c:v>0.0</c:v>
                </c:pt>
                <c:pt idx="1">
                  <c:v>1.260224502766158</c:v>
                </c:pt>
                <c:pt idx="2">
                  <c:v>-1.382504337285879</c:v>
                </c:pt>
                <c:pt idx="3">
                  <c:v>1.110589710299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4131440"/>
        <c:axId val="-2109473280"/>
      </c:barChart>
      <c:catAx>
        <c:axId val="-21041314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-2109473280"/>
        <c:crosses val="autoZero"/>
        <c:auto val="1"/>
        <c:lblAlgn val="ctr"/>
        <c:lblOffset val="100"/>
        <c:noMultiLvlLbl val="0"/>
      </c:catAx>
      <c:valAx>
        <c:axId val="-2109473280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Log relative express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0413144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31"/>
            <a:ext cx="7772401" cy="1470025"/>
          </a:xfrm>
        </p:spPr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1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u-H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2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864197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2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712859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2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2312481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2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8107916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6"/>
            <a:ext cx="7772401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9"/>
            <a:ext cx="7772401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2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895057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2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2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088362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7" y="1535113"/>
            <a:ext cx="404018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7" y="2174875"/>
            <a:ext cx="404018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32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32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2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774888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2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792546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2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7556219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3" y="273051"/>
            <a:ext cx="3008312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6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3" y="1435100"/>
            <a:ext cx="3008312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2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413229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2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337249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3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3" y="1600206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2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3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1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5335995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1" y="23005"/>
            <a:ext cx="883701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S7:</a:t>
            </a:r>
            <a:r>
              <a:rPr lang="en-US" sz="1400" dirty="0" smtClean="0"/>
              <a:t> </a:t>
            </a:r>
            <a:r>
              <a:rPr lang="en-US" sz="1400" b="1" dirty="0" smtClean="0"/>
              <a:t>Overexpression of DAF-16 target in </a:t>
            </a:r>
            <a:r>
              <a:rPr lang="en-US" sz="1400" b="1" i="1" dirty="0" smtClean="0"/>
              <a:t>let-418</a:t>
            </a:r>
            <a:r>
              <a:rPr lang="en-US" sz="1400" b="1" dirty="0" smtClean="0"/>
              <a:t> mutant is only partially dependent on DAF-16</a:t>
            </a:r>
            <a:r>
              <a:rPr lang="en-US" sz="1400" dirty="0" smtClean="0"/>
              <a:t>. </a:t>
            </a:r>
            <a:r>
              <a:rPr lang="en-US" sz="1400" dirty="0"/>
              <a:t>mRNA level of </a:t>
            </a:r>
            <a:r>
              <a:rPr lang="en-US" sz="1400" i="1" dirty="0"/>
              <a:t>dct-3</a:t>
            </a:r>
            <a:r>
              <a:rPr lang="en-US" sz="1400" dirty="0"/>
              <a:t>, </a:t>
            </a:r>
            <a:r>
              <a:rPr lang="en-US" sz="1400" i="1" dirty="0"/>
              <a:t>W08A12.4</a:t>
            </a:r>
            <a:r>
              <a:rPr lang="en-US" sz="1400" dirty="0"/>
              <a:t> and </a:t>
            </a:r>
            <a:r>
              <a:rPr lang="en-US" sz="1400" i="1" dirty="0"/>
              <a:t>fbxa-165</a:t>
            </a:r>
            <a:r>
              <a:rPr lang="en-US" sz="1400" dirty="0"/>
              <a:t> was measured by </a:t>
            </a:r>
            <a:r>
              <a:rPr lang="en-US" sz="1400" dirty="0" err="1"/>
              <a:t>qRT</a:t>
            </a:r>
            <a:r>
              <a:rPr lang="en-US" sz="1400" dirty="0"/>
              <a:t>-PCR and represented as </a:t>
            </a:r>
            <a:r>
              <a:rPr lang="en-US" sz="1400" dirty="0" smtClean="0"/>
              <a:t>the log10 of fold induction. </a:t>
            </a:r>
            <a:r>
              <a:rPr lang="en-US" sz="1400" dirty="0"/>
              <a:t>Total mRNA was isolated from L1 animals of the indicated genotype. </a:t>
            </a:r>
            <a:r>
              <a:rPr lang="en-US" sz="1400" i="1" dirty="0"/>
              <a:t>ama-1</a:t>
            </a:r>
            <a:r>
              <a:rPr lang="en-US" sz="1400" dirty="0"/>
              <a:t> was used to normalize. </a:t>
            </a:r>
          </a:p>
        </p:txBody>
      </p:sp>
      <p:graphicFrame>
        <p:nvGraphicFramePr>
          <p:cNvPr id="18" name="Chart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4642107"/>
              </p:ext>
            </p:extLst>
          </p:nvPr>
        </p:nvGraphicFramePr>
        <p:xfrm>
          <a:off x="265994" y="1031688"/>
          <a:ext cx="4065223" cy="25621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4" name="Chart 3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8814104"/>
              </p:ext>
            </p:extLst>
          </p:nvPr>
        </p:nvGraphicFramePr>
        <p:xfrm>
          <a:off x="4573588" y="1031688"/>
          <a:ext cx="4074653" cy="25621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5" name="Chart 3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10820208"/>
              </p:ext>
            </p:extLst>
          </p:nvPr>
        </p:nvGraphicFramePr>
        <p:xfrm>
          <a:off x="89725" y="3863891"/>
          <a:ext cx="4096686" cy="26470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1922966696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697</TotalTime>
  <Words>74</Words>
  <Application>Microsoft Macintosh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2_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tal WIcky</dc:creator>
  <cp:lastModifiedBy>Microsoft Office User</cp:lastModifiedBy>
  <cp:revision>54</cp:revision>
  <cp:lastPrinted>2016-11-17T08:14:39Z</cp:lastPrinted>
  <dcterms:created xsi:type="dcterms:W3CDTF">2016-05-11T08:55:17Z</dcterms:created>
  <dcterms:modified xsi:type="dcterms:W3CDTF">2016-12-22T08:05:57Z</dcterms:modified>
</cp:coreProperties>
</file>